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0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8/05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5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5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5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5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5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5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5/2019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5/2019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5/2019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5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5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8/05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80984" y="5733256"/>
            <a:ext cx="722732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Ewan R. Pearson (2019) Diabetologia DOI 10.1007/s00125-019-4909-y</a:t>
            </a:r>
          </a:p>
          <a:p>
            <a:r>
              <a:rPr lang="en-GB" sz="1200" dirty="0"/>
              <a:t>Adapted from McCarthy MI (2017) Diabetologia, under the terms of the Creative Commons Attribution 4.0 International License (http://creativecommons.org/licenses/by/4.0/) 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86462" y="47488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Deconvoluting the diabetes component pathways</a:t>
            </a:r>
            <a:endParaRPr lang="en-GB" sz="20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84676F8-4E0D-4DDD-8B33-7090BAFBE26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7222" y="1730134"/>
            <a:ext cx="8911448" cy="35800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2</TotalTime>
  <Words>51</Words>
  <Application>Microsoft Office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ose Ruffino</cp:lastModifiedBy>
  <cp:revision>32</cp:revision>
  <dcterms:created xsi:type="dcterms:W3CDTF">2016-06-15T12:53:43Z</dcterms:created>
  <dcterms:modified xsi:type="dcterms:W3CDTF">2019-05-28T13:39:22Z</dcterms:modified>
</cp:coreProperties>
</file>